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36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012"/>
    <p:restoredTop sz="94898"/>
  </p:normalViewPr>
  <p:slideViewPr>
    <p:cSldViewPr snapToGrid="0" showGuides="1">
      <p:cViewPr varScale="1">
        <p:scale>
          <a:sx n="84" d="100"/>
          <a:sy n="84" d="100"/>
        </p:scale>
        <p:origin x="4576" y="184"/>
      </p:cViewPr>
      <p:guideLst>
        <p:guide pos="2160"/>
        <p:guide orient="horz" pos="364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onomareva, Ekaterina (AAFC/AAC)" userId="61ae2b3b-beee-48a8-8f9b-167703963909" providerId="ADAL" clId="{EA982A94-14E8-49B6-B068-65D9953311F4}"/>
    <pc:docChg chg="modSld">
      <pc:chgData name="Ponomareva, Ekaterina (AAFC/AAC)" userId="61ae2b3b-beee-48a8-8f9b-167703963909" providerId="ADAL" clId="{EA982A94-14E8-49B6-B068-65D9953311F4}" dt="2025-04-11T18:55:48.491" v="1" actId="20577"/>
      <pc:docMkLst>
        <pc:docMk/>
      </pc:docMkLst>
      <pc:sldChg chg="modSp mod">
        <pc:chgData name="Ponomareva, Ekaterina (AAFC/AAC)" userId="61ae2b3b-beee-48a8-8f9b-167703963909" providerId="ADAL" clId="{EA982A94-14E8-49B6-B068-65D9953311F4}" dt="2025-04-11T18:55:48.491" v="1" actId="20577"/>
        <pc:sldMkLst>
          <pc:docMk/>
          <pc:sldMk cId="1403263095" sldId="257"/>
        </pc:sldMkLst>
        <pc:spChg chg="mod">
          <ac:chgData name="Ponomareva, Ekaterina (AAFC/AAC)" userId="61ae2b3b-beee-48a8-8f9b-167703963909" providerId="ADAL" clId="{EA982A94-14E8-49B6-B068-65D9953311F4}" dt="2025-04-11T18:55:48.491" v="1" actId="20577"/>
          <ac:spMkLst>
            <pc:docMk/>
            <pc:sldMk cId="1403263095" sldId="257"/>
            <ac:spMk id="8" creationId="{EEFD7CE9-56C7-AB5C-34F0-9B3EF0EF6D6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58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4216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836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024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388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09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889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4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545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333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666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7E666A-1672-0A48-86CF-1F4C90134621}" type="datetimeFigureOut">
              <a:rPr kumimoji="1" lang="ja-JP" altLang="en-US" smtClean="0"/>
              <a:t>2025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08793C-3EAD-754B-861B-B1A4DA0E92F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14665C-5E94-77E3-E6F7-32300C7723F5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429250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en-US" sz="10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137231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53F9A8-9885-0688-FBED-1F9B7C3594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A diagram of different colors and numbers">
            <a:extLst>
              <a:ext uri="{FF2B5EF4-FFF2-40B4-BE49-F238E27FC236}">
                <a16:creationId xmlns:a16="http://schemas.microsoft.com/office/drawing/2014/main" id="{8CE64D52-9B90-1A71-AE8A-1D954A2BE7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89246"/>
            <a:ext cx="3562782" cy="495300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FD7CE9-56C7-AB5C-34F0-9B3EF0EF6D60}"/>
              </a:ext>
            </a:extLst>
          </p:cNvPr>
          <p:cNvSpPr txBox="1"/>
          <p:nvPr/>
        </p:nvSpPr>
        <p:spPr>
          <a:xfrm>
            <a:off x="66891" y="4953000"/>
            <a:ext cx="3429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</a:t>
            </a:r>
            <a:r>
              <a:rPr lang="en-US" altLang="ja-JP" sz="1200" b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1.</a:t>
            </a:r>
            <a:r>
              <a:rPr lang="en-US" altLang="ja-JP" sz="12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Venn diagram depicting the number of shared CRN-predicted protein clusters among the various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hytophthora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strains.</a:t>
            </a:r>
            <a:r>
              <a:rPr lang="ja-JP" altLang="ja-JP" sz="1200" dirty="0">
                <a:effectLst/>
              </a:rPr>
              <a:t>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03263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角丸四角形 1">
            <a:extLst>
              <a:ext uri="{FF2B5EF4-FFF2-40B4-BE49-F238E27FC236}">
                <a16:creationId xmlns:a16="http://schemas.microsoft.com/office/drawing/2014/main" id="{0AF7752A-9D58-964B-CFB0-B759A1168402}"/>
              </a:ext>
            </a:extLst>
          </p:cNvPr>
          <p:cNvSpPr/>
          <p:nvPr/>
        </p:nvSpPr>
        <p:spPr>
          <a:xfrm>
            <a:off x="55112" y="2537515"/>
            <a:ext cx="7530078" cy="1572013"/>
          </a:xfrm>
          <a:prstGeom prst="roundRect">
            <a:avLst/>
          </a:prstGeom>
          <a:gradFill flip="none" rotWithShape="1">
            <a:gsLst>
              <a:gs pos="0">
                <a:schemeClr val="accent4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87" name="角丸四角形 86">
            <a:extLst>
              <a:ext uri="{FF2B5EF4-FFF2-40B4-BE49-F238E27FC236}">
                <a16:creationId xmlns:a16="http://schemas.microsoft.com/office/drawing/2014/main" id="{471B0E94-D2D4-87C3-931B-C3925AFD8E98}"/>
              </a:ext>
            </a:extLst>
          </p:cNvPr>
          <p:cNvSpPr/>
          <p:nvPr/>
        </p:nvSpPr>
        <p:spPr>
          <a:xfrm>
            <a:off x="11733" y="4211249"/>
            <a:ext cx="7530080" cy="398454"/>
          </a:xfrm>
          <a:prstGeom prst="roundRect">
            <a:avLst/>
          </a:prstGeom>
          <a:gradFill flip="none" rotWithShape="1">
            <a:gsLst>
              <a:gs pos="0">
                <a:schemeClr val="accent5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0" name="角丸四角形 129">
            <a:extLst>
              <a:ext uri="{FF2B5EF4-FFF2-40B4-BE49-F238E27FC236}">
                <a16:creationId xmlns:a16="http://schemas.microsoft.com/office/drawing/2014/main" id="{8C6AC050-C1A1-0316-B02C-45036C45FA73}"/>
              </a:ext>
            </a:extLst>
          </p:cNvPr>
          <p:cNvSpPr/>
          <p:nvPr/>
        </p:nvSpPr>
        <p:spPr>
          <a:xfrm>
            <a:off x="55112" y="4683328"/>
            <a:ext cx="7486701" cy="332559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20000"/>
                  <a:lumOff val="8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1" name="角丸四角形 130">
            <a:extLst>
              <a:ext uri="{FF2B5EF4-FFF2-40B4-BE49-F238E27FC236}">
                <a16:creationId xmlns:a16="http://schemas.microsoft.com/office/drawing/2014/main" id="{CAB05F5F-6B73-9703-6806-343BC1F57406}"/>
              </a:ext>
            </a:extLst>
          </p:cNvPr>
          <p:cNvSpPr/>
          <p:nvPr/>
        </p:nvSpPr>
        <p:spPr>
          <a:xfrm>
            <a:off x="55109" y="5103652"/>
            <a:ext cx="7509176" cy="1617388"/>
          </a:xfrm>
          <a:prstGeom prst="roundRect">
            <a:avLst/>
          </a:prstGeom>
          <a:gradFill flip="none" rotWithShape="1">
            <a:gsLst>
              <a:gs pos="0">
                <a:schemeClr val="bg2">
                  <a:lumMod val="90000"/>
                </a:schemeClr>
              </a:gs>
              <a:gs pos="50000">
                <a:schemeClr val="bg1"/>
              </a:gs>
              <a:gs pos="100000">
                <a:schemeClr val="bg1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/>
          </a:p>
        </p:txBody>
      </p:sp>
      <p:sp>
        <p:nvSpPr>
          <p:cNvPr id="134" name="フリーフォーム 133">
            <a:extLst>
              <a:ext uri="{FF2B5EF4-FFF2-40B4-BE49-F238E27FC236}">
                <a16:creationId xmlns:a16="http://schemas.microsoft.com/office/drawing/2014/main" id="{2697C467-4E42-8630-CBE0-09755FB85743}"/>
              </a:ext>
            </a:extLst>
          </p:cNvPr>
          <p:cNvSpPr/>
          <p:nvPr/>
        </p:nvSpPr>
        <p:spPr>
          <a:xfrm>
            <a:off x="2223926" y="5924531"/>
            <a:ext cx="722937" cy="319130"/>
          </a:xfrm>
          <a:custGeom>
            <a:avLst/>
            <a:gdLst>
              <a:gd name="connsiteX0" fmla="*/ 872978 w 872971"/>
              <a:gd name="connsiteY0" fmla="*/ 6 h 385361"/>
              <a:gd name="connsiteX1" fmla="*/ 6 w 872971"/>
              <a:gd name="connsiteY1" fmla="*/ 6 h 385361"/>
              <a:gd name="connsiteX2" fmla="*/ 6 w 872971"/>
              <a:gd name="connsiteY2" fmla="*/ 385368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385361">
                <a:moveTo>
                  <a:pt x="872978" y="6"/>
                </a:moveTo>
                <a:lnTo>
                  <a:pt x="6" y="6"/>
                </a:lnTo>
                <a:lnTo>
                  <a:pt x="6" y="38536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5" name="フリーフォーム 134">
            <a:extLst>
              <a:ext uri="{FF2B5EF4-FFF2-40B4-BE49-F238E27FC236}">
                <a16:creationId xmlns:a16="http://schemas.microsoft.com/office/drawing/2014/main" id="{EFC1EDF3-81B9-364D-5B85-8EDF422F272F}"/>
              </a:ext>
            </a:extLst>
          </p:cNvPr>
          <p:cNvSpPr/>
          <p:nvPr/>
        </p:nvSpPr>
        <p:spPr>
          <a:xfrm>
            <a:off x="2946863" y="4435256"/>
            <a:ext cx="722937" cy="212752"/>
          </a:xfrm>
          <a:custGeom>
            <a:avLst/>
            <a:gdLst>
              <a:gd name="connsiteX0" fmla="*/ 872978 w 872971"/>
              <a:gd name="connsiteY0" fmla="*/ 6 h 256907"/>
              <a:gd name="connsiteX1" fmla="*/ 6 w 872971"/>
              <a:gd name="connsiteY1" fmla="*/ 6 h 256907"/>
              <a:gd name="connsiteX2" fmla="*/ 6 w 872971"/>
              <a:gd name="connsiteY2" fmla="*/ 256914 h 2569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7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6" name="フリーフォーム 135">
            <a:extLst>
              <a:ext uri="{FF2B5EF4-FFF2-40B4-BE49-F238E27FC236}">
                <a16:creationId xmlns:a16="http://schemas.microsoft.com/office/drawing/2014/main" id="{54CBF58B-1747-82B0-DBE1-0B9DF5E90550}"/>
              </a:ext>
            </a:extLst>
          </p:cNvPr>
          <p:cNvSpPr/>
          <p:nvPr/>
        </p:nvSpPr>
        <p:spPr>
          <a:xfrm>
            <a:off x="1500987" y="5286270"/>
            <a:ext cx="2168812" cy="478692"/>
          </a:xfrm>
          <a:custGeom>
            <a:avLst/>
            <a:gdLst>
              <a:gd name="connsiteX0" fmla="*/ 2618921 w 2618915"/>
              <a:gd name="connsiteY0" fmla="*/ 6 h 578038"/>
              <a:gd name="connsiteX1" fmla="*/ 6 w 2618915"/>
              <a:gd name="connsiteY1" fmla="*/ 6 h 578038"/>
              <a:gd name="connsiteX2" fmla="*/ 6 w 2618915"/>
              <a:gd name="connsiteY2" fmla="*/ 578044 h 5780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5" h="578038">
                <a:moveTo>
                  <a:pt x="2618921" y="6"/>
                </a:moveTo>
                <a:lnTo>
                  <a:pt x="6" y="6"/>
                </a:lnTo>
                <a:lnTo>
                  <a:pt x="6" y="57804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7" name="フリーフォーム 136">
            <a:extLst>
              <a:ext uri="{FF2B5EF4-FFF2-40B4-BE49-F238E27FC236}">
                <a16:creationId xmlns:a16="http://schemas.microsoft.com/office/drawing/2014/main" id="{12FA0BE7-28DC-FA49-657F-86EA4F010AA7}"/>
              </a:ext>
            </a:extLst>
          </p:cNvPr>
          <p:cNvSpPr/>
          <p:nvPr/>
        </p:nvSpPr>
        <p:spPr>
          <a:xfrm>
            <a:off x="778050" y="4648009"/>
            <a:ext cx="2168812" cy="558480"/>
          </a:xfrm>
          <a:custGeom>
            <a:avLst/>
            <a:gdLst>
              <a:gd name="connsiteX0" fmla="*/ 2618921 w 2618914"/>
              <a:gd name="connsiteY0" fmla="*/ 6 h 674385"/>
              <a:gd name="connsiteX1" fmla="*/ 6 w 2618914"/>
              <a:gd name="connsiteY1" fmla="*/ 6 h 674385"/>
              <a:gd name="connsiteX2" fmla="*/ 6 w 2618914"/>
              <a:gd name="connsiteY2" fmla="*/ 674392 h 6743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4" h="674385">
                <a:moveTo>
                  <a:pt x="2618921" y="6"/>
                </a:moveTo>
                <a:lnTo>
                  <a:pt x="6" y="6"/>
                </a:lnTo>
                <a:lnTo>
                  <a:pt x="6" y="674392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8" name="フリーフォーム 137">
            <a:extLst>
              <a:ext uri="{FF2B5EF4-FFF2-40B4-BE49-F238E27FC236}">
                <a16:creationId xmlns:a16="http://schemas.microsoft.com/office/drawing/2014/main" id="{28C484F0-0AE9-3A37-F6B6-36F38FA84D1D}"/>
              </a:ext>
            </a:extLst>
          </p:cNvPr>
          <p:cNvSpPr/>
          <p:nvPr/>
        </p:nvSpPr>
        <p:spPr>
          <a:xfrm>
            <a:off x="-711200" y="5572158"/>
            <a:ext cx="43377" cy="7248"/>
          </a:xfrm>
          <a:custGeom>
            <a:avLst/>
            <a:gdLst>
              <a:gd name="connsiteX0" fmla="*/ 6 w 52378"/>
              <a:gd name="connsiteY0" fmla="*/ 6 h 8753"/>
              <a:gd name="connsiteX1" fmla="*/ 52384 w 52378"/>
              <a:gd name="connsiteY1" fmla="*/ 6 h 87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2378" h="8753">
                <a:moveTo>
                  <a:pt x="6" y="6"/>
                </a:moveTo>
                <a:lnTo>
                  <a:pt x="52384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9" name="フリーフォーム 138">
            <a:extLst>
              <a:ext uri="{FF2B5EF4-FFF2-40B4-BE49-F238E27FC236}">
                <a16:creationId xmlns:a16="http://schemas.microsoft.com/office/drawing/2014/main" id="{E0D2106C-E0D0-92A1-A752-B5653B6A61EA}"/>
              </a:ext>
            </a:extLst>
          </p:cNvPr>
          <p:cNvSpPr/>
          <p:nvPr/>
        </p:nvSpPr>
        <p:spPr>
          <a:xfrm>
            <a:off x="2946863" y="4648010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0" name="フリーフォーム 139">
            <a:extLst>
              <a:ext uri="{FF2B5EF4-FFF2-40B4-BE49-F238E27FC236}">
                <a16:creationId xmlns:a16="http://schemas.microsoft.com/office/drawing/2014/main" id="{1A444F5E-AAFE-F069-D123-A28CB87F1857}"/>
              </a:ext>
            </a:extLst>
          </p:cNvPr>
          <p:cNvSpPr/>
          <p:nvPr/>
        </p:nvSpPr>
        <p:spPr>
          <a:xfrm>
            <a:off x="2946863" y="5711778"/>
            <a:ext cx="722937" cy="212754"/>
          </a:xfrm>
          <a:custGeom>
            <a:avLst/>
            <a:gdLst>
              <a:gd name="connsiteX0" fmla="*/ 872978 w 872971"/>
              <a:gd name="connsiteY0" fmla="*/ 6 h 256908"/>
              <a:gd name="connsiteX1" fmla="*/ 6 w 872971"/>
              <a:gd name="connsiteY1" fmla="*/ 6 h 256908"/>
              <a:gd name="connsiteX2" fmla="*/ 6 w 872971"/>
              <a:gd name="connsiteY2" fmla="*/ 256914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1" name="フリーフォーム 140">
            <a:extLst>
              <a:ext uri="{FF2B5EF4-FFF2-40B4-BE49-F238E27FC236}">
                <a16:creationId xmlns:a16="http://schemas.microsoft.com/office/drawing/2014/main" id="{1971EB4A-9F18-8ACE-D001-D8B324D93D84}"/>
              </a:ext>
            </a:extLst>
          </p:cNvPr>
          <p:cNvSpPr/>
          <p:nvPr/>
        </p:nvSpPr>
        <p:spPr>
          <a:xfrm>
            <a:off x="2223924" y="3158734"/>
            <a:ext cx="1445874" cy="319130"/>
          </a:xfrm>
          <a:custGeom>
            <a:avLst/>
            <a:gdLst>
              <a:gd name="connsiteX0" fmla="*/ 1745949 w 1745943"/>
              <a:gd name="connsiteY0" fmla="*/ 6 h 385361"/>
              <a:gd name="connsiteX1" fmla="*/ 6 w 1745943"/>
              <a:gd name="connsiteY1" fmla="*/ 6 h 385361"/>
              <a:gd name="connsiteX2" fmla="*/ 6 w 1745943"/>
              <a:gd name="connsiteY2" fmla="*/ 385368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385361">
                <a:moveTo>
                  <a:pt x="1745949" y="6"/>
                </a:moveTo>
                <a:lnTo>
                  <a:pt x="6" y="6"/>
                </a:lnTo>
                <a:lnTo>
                  <a:pt x="6" y="38536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2" name="フリーフォーム 141">
            <a:extLst>
              <a:ext uri="{FF2B5EF4-FFF2-40B4-BE49-F238E27FC236}">
                <a16:creationId xmlns:a16="http://schemas.microsoft.com/office/drawing/2014/main" id="{A4A91D0B-0E3D-EF5C-E196-E1F0915F3C63}"/>
              </a:ext>
            </a:extLst>
          </p:cNvPr>
          <p:cNvSpPr/>
          <p:nvPr/>
        </p:nvSpPr>
        <p:spPr>
          <a:xfrm>
            <a:off x="2223924" y="6243661"/>
            <a:ext cx="1445874" cy="319130"/>
          </a:xfrm>
          <a:custGeom>
            <a:avLst/>
            <a:gdLst>
              <a:gd name="connsiteX0" fmla="*/ 1745949 w 1745943"/>
              <a:gd name="connsiteY0" fmla="*/ 385368 h 385361"/>
              <a:gd name="connsiteX1" fmla="*/ 6 w 1745943"/>
              <a:gd name="connsiteY1" fmla="*/ 385368 h 385361"/>
              <a:gd name="connsiteX2" fmla="*/ 6 w 1745943"/>
              <a:gd name="connsiteY2" fmla="*/ 6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385361">
                <a:moveTo>
                  <a:pt x="1745949" y="385368"/>
                </a:moveTo>
                <a:lnTo>
                  <a:pt x="6" y="385368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3" name="フリーフォーム 142">
            <a:extLst>
              <a:ext uri="{FF2B5EF4-FFF2-40B4-BE49-F238E27FC236}">
                <a16:creationId xmlns:a16="http://schemas.microsoft.com/office/drawing/2014/main" id="{4EE99B74-EC09-8A3B-C2ED-D4537A24ECA5}"/>
              </a:ext>
            </a:extLst>
          </p:cNvPr>
          <p:cNvSpPr/>
          <p:nvPr/>
        </p:nvSpPr>
        <p:spPr>
          <a:xfrm>
            <a:off x="1500987" y="2733228"/>
            <a:ext cx="2168812" cy="372319"/>
          </a:xfrm>
          <a:custGeom>
            <a:avLst/>
            <a:gdLst>
              <a:gd name="connsiteX0" fmla="*/ 2618921 w 2618915"/>
              <a:gd name="connsiteY0" fmla="*/ 6 h 449588"/>
              <a:gd name="connsiteX1" fmla="*/ 6 w 2618915"/>
              <a:gd name="connsiteY1" fmla="*/ 6 h 449588"/>
              <a:gd name="connsiteX2" fmla="*/ 6 w 2618915"/>
              <a:gd name="connsiteY2" fmla="*/ 449595 h 4495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618915" h="449588">
                <a:moveTo>
                  <a:pt x="2618921" y="6"/>
                </a:moveTo>
                <a:lnTo>
                  <a:pt x="6" y="6"/>
                </a:lnTo>
                <a:lnTo>
                  <a:pt x="6" y="449595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4" name="フリーフォーム 143">
            <a:extLst>
              <a:ext uri="{FF2B5EF4-FFF2-40B4-BE49-F238E27FC236}">
                <a16:creationId xmlns:a16="http://schemas.microsoft.com/office/drawing/2014/main" id="{E1B7A95B-9DBB-D701-C298-B84C533947E5}"/>
              </a:ext>
            </a:extLst>
          </p:cNvPr>
          <p:cNvSpPr/>
          <p:nvPr/>
        </p:nvSpPr>
        <p:spPr>
          <a:xfrm>
            <a:off x="1500989" y="5764964"/>
            <a:ext cx="722937" cy="478699"/>
          </a:xfrm>
          <a:custGeom>
            <a:avLst/>
            <a:gdLst>
              <a:gd name="connsiteX0" fmla="*/ 872978 w 872971"/>
              <a:gd name="connsiteY0" fmla="*/ 578053 h 578047"/>
              <a:gd name="connsiteX1" fmla="*/ 6 w 872971"/>
              <a:gd name="connsiteY1" fmla="*/ 578053 h 578047"/>
              <a:gd name="connsiteX2" fmla="*/ 6 w 872971"/>
              <a:gd name="connsiteY2" fmla="*/ 6 h 578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578047">
                <a:moveTo>
                  <a:pt x="872978" y="578053"/>
                </a:moveTo>
                <a:lnTo>
                  <a:pt x="6" y="578053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5" name="フリーフォーム 144">
            <a:extLst>
              <a:ext uri="{FF2B5EF4-FFF2-40B4-BE49-F238E27FC236}">
                <a16:creationId xmlns:a16="http://schemas.microsoft.com/office/drawing/2014/main" id="{302682ED-C1B5-F9DF-FF14-968C31371E76}"/>
              </a:ext>
            </a:extLst>
          </p:cNvPr>
          <p:cNvSpPr/>
          <p:nvPr/>
        </p:nvSpPr>
        <p:spPr>
          <a:xfrm>
            <a:off x="55114" y="4156016"/>
            <a:ext cx="722937" cy="1050474"/>
          </a:xfrm>
          <a:custGeom>
            <a:avLst/>
            <a:gdLst>
              <a:gd name="connsiteX0" fmla="*/ 872978 w 872971"/>
              <a:gd name="connsiteY0" fmla="*/ 1268492 h 1268486"/>
              <a:gd name="connsiteX1" fmla="*/ 6 w 872971"/>
              <a:gd name="connsiteY1" fmla="*/ 1268492 h 1268486"/>
              <a:gd name="connsiteX2" fmla="*/ 6 w 872971"/>
              <a:gd name="connsiteY2" fmla="*/ 6 h 12684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1268486">
                <a:moveTo>
                  <a:pt x="872978" y="1268492"/>
                </a:moveTo>
                <a:lnTo>
                  <a:pt x="6" y="1268492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6" name="フリーフォーム 145">
            <a:extLst>
              <a:ext uri="{FF2B5EF4-FFF2-40B4-BE49-F238E27FC236}">
                <a16:creationId xmlns:a16="http://schemas.microsoft.com/office/drawing/2014/main" id="{44F9AAB5-9CCA-CF05-33CF-B1E1E9D0E621}"/>
              </a:ext>
            </a:extLst>
          </p:cNvPr>
          <p:cNvSpPr/>
          <p:nvPr/>
        </p:nvSpPr>
        <p:spPr>
          <a:xfrm>
            <a:off x="-667823" y="4156016"/>
            <a:ext cx="722936" cy="1416142"/>
          </a:xfrm>
          <a:custGeom>
            <a:avLst/>
            <a:gdLst>
              <a:gd name="connsiteX0" fmla="*/ 872976 w 872969"/>
              <a:gd name="connsiteY0" fmla="*/ 6 h 1710044"/>
              <a:gd name="connsiteX1" fmla="*/ 6 w 872969"/>
              <a:gd name="connsiteY1" fmla="*/ 6 h 1710044"/>
              <a:gd name="connsiteX2" fmla="*/ 6 w 872969"/>
              <a:gd name="connsiteY2" fmla="*/ 1710050 h 17100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69" h="1710044">
                <a:moveTo>
                  <a:pt x="872976" y="6"/>
                </a:moveTo>
                <a:lnTo>
                  <a:pt x="6" y="6"/>
                </a:lnTo>
                <a:lnTo>
                  <a:pt x="6" y="1710050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7" name="フリーフォーム 146">
            <a:extLst>
              <a:ext uri="{FF2B5EF4-FFF2-40B4-BE49-F238E27FC236}">
                <a16:creationId xmlns:a16="http://schemas.microsoft.com/office/drawing/2014/main" id="{5B519475-D626-9E81-110A-B7ADC103C91C}"/>
              </a:ext>
            </a:extLst>
          </p:cNvPr>
          <p:cNvSpPr/>
          <p:nvPr/>
        </p:nvSpPr>
        <p:spPr>
          <a:xfrm>
            <a:off x="2946863" y="3584241"/>
            <a:ext cx="722937" cy="212752"/>
          </a:xfrm>
          <a:custGeom>
            <a:avLst/>
            <a:gdLst>
              <a:gd name="connsiteX0" fmla="*/ 872978 w 872971"/>
              <a:gd name="connsiteY0" fmla="*/ 6 h 256907"/>
              <a:gd name="connsiteX1" fmla="*/ 6 w 872971"/>
              <a:gd name="connsiteY1" fmla="*/ 6 h 256907"/>
              <a:gd name="connsiteX2" fmla="*/ 6 w 872971"/>
              <a:gd name="connsiteY2" fmla="*/ 256914 h 2569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7">
                <a:moveTo>
                  <a:pt x="872978" y="6"/>
                </a:moveTo>
                <a:lnTo>
                  <a:pt x="6" y="6"/>
                </a:lnTo>
                <a:lnTo>
                  <a:pt x="6" y="256914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8" name="フリーフォーム 147">
            <a:extLst>
              <a:ext uri="{FF2B5EF4-FFF2-40B4-BE49-F238E27FC236}">
                <a16:creationId xmlns:a16="http://schemas.microsoft.com/office/drawing/2014/main" id="{384C2F50-B085-FFB9-0DBA-A8A24D8491B4}"/>
              </a:ext>
            </a:extLst>
          </p:cNvPr>
          <p:cNvSpPr/>
          <p:nvPr/>
        </p:nvSpPr>
        <p:spPr>
          <a:xfrm>
            <a:off x="-667823" y="5572158"/>
            <a:ext cx="4337622" cy="1416142"/>
          </a:xfrm>
          <a:custGeom>
            <a:avLst/>
            <a:gdLst>
              <a:gd name="connsiteX0" fmla="*/ 5237835 w 5237828"/>
              <a:gd name="connsiteY0" fmla="*/ 1710050 h 1710044"/>
              <a:gd name="connsiteX1" fmla="*/ 6 w 5237828"/>
              <a:gd name="connsiteY1" fmla="*/ 1710050 h 1710044"/>
              <a:gd name="connsiteX2" fmla="*/ 6 w 5237828"/>
              <a:gd name="connsiteY2" fmla="*/ 6 h 17100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37828" h="1710044">
                <a:moveTo>
                  <a:pt x="5237835" y="1710050"/>
                </a:moveTo>
                <a:lnTo>
                  <a:pt x="6" y="1710050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49" name="フリーフォーム 148">
            <a:extLst>
              <a:ext uri="{FF2B5EF4-FFF2-40B4-BE49-F238E27FC236}">
                <a16:creationId xmlns:a16="http://schemas.microsoft.com/office/drawing/2014/main" id="{1A3419B8-8664-C168-152E-EEC39188EDA2}"/>
              </a:ext>
            </a:extLst>
          </p:cNvPr>
          <p:cNvSpPr/>
          <p:nvPr/>
        </p:nvSpPr>
        <p:spPr>
          <a:xfrm>
            <a:off x="778052" y="5206491"/>
            <a:ext cx="722937" cy="558473"/>
          </a:xfrm>
          <a:custGeom>
            <a:avLst/>
            <a:gdLst>
              <a:gd name="connsiteX0" fmla="*/ 872978 w 872971"/>
              <a:gd name="connsiteY0" fmla="*/ 674383 h 674376"/>
              <a:gd name="connsiteX1" fmla="*/ 6 w 872971"/>
              <a:gd name="connsiteY1" fmla="*/ 674383 h 674376"/>
              <a:gd name="connsiteX2" fmla="*/ 6 w 872971"/>
              <a:gd name="connsiteY2" fmla="*/ 6 h 6743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674376">
                <a:moveTo>
                  <a:pt x="872978" y="674383"/>
                </a:moveTo>
                <a:lnTo>
                  <a:pt x="6" y="674383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0" name="フリーフォーム 149">
            <a:extLst>
              <a:ext uri="{FF2B5EF4-FFF2-40B4-BE49-F238E27FC236}">
                <a16:creationId xmlns:a16="http://schemas.microsoft.com/office/drawing/2014/main" id="{FDBDFC81-4E8E-F402-F70E-DE39650A9CA6}"/>
              </a:ext>
            </a:extLst>
          </p:cNvPr>
          <p:cNvSpPr/>
          <p:nvPr/>
        </p:nvSpPr>
        <p:spPr>
          <a:xfrm>
            <a:off x="2946863" y="3796995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1" name="フリーフォーム 150">
            <a:extLst>
              <a:ext uri="{FF2B5EF4-FFF2-40B4-BE49-F238E27FC236}">
                <a16:creationId xmlns:a16="http://schemas.microsoft.com/office/drawing/2014/main" id="{1815C7BE-EDA2-CF11-569B-1215D0F9466E}"/>
              </a:ext>
            </a:extLst>
          </p:cNvPr>
          <p:cNvSpPr/>
          <p:nvPr/>
        </p:nvSpPr>
        <p:spPr>
          <a:xfrm>
            <a:off x="2223926" y="3477865"/>
            <a:ext cx="722937" cy="319130"/>
          </a:xfrm>
          <a:custGeom>
            <a:avLst/>
            <a:gdLst>
              <a:gd name="connsiteX0" fmla="*/ 872978 w 872971"/>
              <a:gd name="connsiteY0" fmla="*/ 385368 h 385361"/>
              <a:gd name="connsiteX1" fmla="*/ 6 w 872971"/>
              <a:gd name="connsiteY1" fmla="*/ 385368 h 385361"/>
              <a:gd name="connsiteX2" fmla="*/ 6 w 872971"/>
              <a:gd name="connsiteY2" fmla="*/ 6 h 385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385361">
                <a:moveTo>
                  <a:pt x="872978" y="385368"/>
                </a:moveTo>
                <a:lnTo>
                  <a:pt x="6" y="385368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2" name="フリーフォーム 151">
            <a:extLst>
              <a:ext uri="{FF2B5EF4-FFF2-40B4-BE49-F238E27FC236}">
                <a16:creationId xmlns:a16="http://schemas.microsoft.com/office/drawing/2014/main" id="{2B848E49-38CB-E843-7618-9470FB86FFD5}"/>
              </a:ext>
            </a:extLst>
          </p:cNvPr>
          <p:cNvSpPr/>
          <p:nvPr/>
        </p:nvSpPr>
        <p:spPr>
          <a:xfrm>
            <a:off x="1500989" y="3105546"/>
            <a:ext cx="722937" cy="372319"/>
          </a:xfrm>
          <a:custGeom>
            <a:avLst/>
            <a:gdLst>
              <a:gd name="connsiteX0" fmla="*/ 872978 w 872971"/>
              <a:gd name="connsiteY0" fmla="*/ 449595 h 449588"/>
              <a:gd name="connsiteX1" fmla="*/ 6 w 872971"/>
              <a:gd name="connsiteY1" fmla="*/ 449595 h 449588"/>
              <a:gd name="connsiteX2" fmla="*/ 6 w 872971"/>
              <a:gd name="connsiteY2" fmla="*/ 6 h 4495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449588">
                <a:moveTo>
                  <a:pt x="872978" y="449595"/>
                </a:moveTo>
                <a:lnTo>
                  <a:pt x="6" y="449595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3" name="フリーフォーム 152">
            <a:extLst>
              <a:ext uri="{FF2B5EF4-FFF2-40B4-BE49-F238E27FC236}">
                <a16:creationId xmlns:a16="http://schemas.microsoft.com/office/drawing/2014/main" id="{DA0399E6-946B-13BD-1191-13D8C455D3DF}"/>
              </a:ext>
            </a:extLst>
          </p:cNvPr>
          <p:cNvSpPr/>
          <p:nvPr/>
        </p:nvSpPr>
        <p:spPr>
          <a:xfrm>
            <a:off x="55113" y="3105546"/>
            <a:ext cx="1445874" cy="1050469"/>
          </a:xfrm>
          <a:custGeom>
            <a:avLst/>
            <a:gdLst>
              <a:gd name="connsiteX0" fmla="*/ 1745949 w 1745943"/>
              <a:gd name="connsiteY0" fmla="*/ 6 h 1268481"/>
              <a:gd name="connsiteX1" fmla="*/ 6 w 1745943"/>
              <a:gd name="connsiteY1" fmla="*/ 6 h 1268481"/>
              <a:gd name="connsiteX2" fmla="*/ 6 w 1745943"/>
              <a:gd name="connsiteY2" fmla="*/ 1268488 h 1268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745943" h="1268481">
                <a:moveTo>
                  <a:pt x="1745949" y="6"/>
                </a:moveTo>
                <a:lnTo>
                  <a:pt x="6" y="6"/>
                </a:lnTo>
                <a:lnTo>
                  <a:pt x="6" y="1268488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4" name="フリーフォーム 153">
            <a:extLst>
              <a:ext uri="{FF2B5EF4-FFF2-40B4-BE49-F238E27FC236}">
                <a16:creationId xmlns:a16="http://schemas.microsoft.com/office/drawing/2014/main" id="{1BB4D682-5DB6-F92C-FA42-13584E907B04}"/>
              </a:ext>
            </a:extLst>
          </p:cNvPr>
          <p:cNvSpPr/>
          <p:nvPr/>
        </p:nvSpPr>
        <p:spPr>
          <a:xfrm>
            <a:off x="2946863" y="5924532"/>
            <a:ext cx="722937" cy="212754"/>
          </a:xfrm>
          <a:custGeom>
            <a:avLst/>
            <a:gdLst>
              <a:gd name="connsiteX0" fmla="*/ 872978 w 872971"/>
              <a:gd name="connsiteY0" fmla="*/ 256914 h 256908"/>
              <a:gd name="connsiteX1" fmla="*/ 6 w 872971"/>
              <a:gd name="connsiteY1" fmla="*/ 256914 h 256908"/>
              <a:gd name="connsiteX2" fmla="*/ 6 w 872971"/>
              <a:gd name="connsiteY2" fmla="*/ 6 h 256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72971" h="256908">
                <a:moveTo>
                  <a:pt x="872978" y="256914"/>
                </a:moveTo>
                <a:lnTo>
                  <a:pt x="6" y="256914"/>
                </a:lnTo>
                <a:lnTo>
                  <a:pt x="6" y="6"/>
                </a:lnTo>
              </a:path>
            </a:pathLst>
          </a:custGeom>
          <a:noFill/>
          <a:ln w="8759" cap="rnd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ja-JP" altLang="en-US" sz="52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D3BA88A5-9788-5396-BDBB-51AD56EB3413}"/>
              </a:ext>
            </a:extLst>
          </p:cNvPr>
          <p:cNvSpPr txBox="1"/>
          <p:nvPr/>
        </p:nvSpPr>
        <p:spPr>
          <a:xfrm>
            <a:off x="3666608" y="2537514"/>
            <a:ext cx="266932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</a:t>
            </a:r>
            <a:r>
              <a:rPr lang="en-US" altLang="ja-JP" sz="1517" i="1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 </a:t>
            </a:r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sansomeana</a:t>
            </a:r>
            <a:r>
              <a:rPr lang="en-US" altLang="ja-JP" sz="1517" i="1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san68</a:t>
            </a: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36CF3F63-D17C-FEBB-EC9F-92D41137CDA2}"/>
              </a:ext>
            </a:extLst>
          </p:cNvPr>
          <p:cNvSpPr txBox="1"/>
          <p:nvPr/>
        </p:nvSpPr>
        <p:spPr>
          <a:xfrm>
            <a:off x="3666609" y="4239544"/>
            <a:ext cx="3103735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brassicae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bras OSU 2014</a:t>
            </a: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F4ADD35C-1A12-E729-C265-8AB776E85FE9}"/>
              </a:ext>
            </a:extLst>
          </p:cNvPr>
          <p:cNvSpPr txBox="1"/>
          <p:nvPr/>
        </p:nvSpPr>
        <p:spPr>
          <a:xfrm>
            <a:off x="3666608" y="5090558"/>
            <a:ext cx="288252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foliorum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foli OSU 2014</a:t>
            </a: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18FA0A30-729C-6AE5-A365-3CDE4D6E1C62}"/>
              </a:ext>
            </a:extLst>
          </p:cNvPr>
          <p:cNvSpPr txBox="1"/>
          <p:nvPr/>
        </p:nvSpPr>
        <p:spPr>
          <a:xfrm>
            <a:off x="3666608" y="3388529"/>
            <a:ext cx="277672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ryptoge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418.71</a:t>
            </a: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5BF93CF-A15A-D343-9D8C-537ADE7E1242}"/>
              </a:ext>
            </a:extLst>
          </p:cNvPr>
          <p:cNvSpPr txBox="1"/>
          <p:nvPr/>
        </p:nvSpPr>
        <p:spPr>
          <a:xfrm>
            <a:off x="3666608" y="6792588"/>
            <a:ext cx="2847254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innamomi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44.22</a:t>
            </a: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DD72FD35-449D-3E02-8818-FD27608D9B61}"/>
              </a:ext>
            </a:extLst>
          </p:cNvPr>
          <p:cNvSpPr txBox="1"/>
          <p:nvPr/>
        </p:nvSpPr>
        <p:spPr>
          <a:xfrm>
            <a:off x="3666608" y="3814036"/>
            <a:ext cx="276505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cryptoge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13.19</a:t>
            </a: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5B7A4EE9-A66A-92F3-2311-F4C289FB51DE}"/>
              </a:ext>
            </a:extLst>
          </p:cNvPr>
          <p:cNvSpPr txBox="1"/>
          <p:nvPr/>
        </p:nvSpPr>
        <p:spPr>
          <a:xfrm>
            <a:off x="3666610" y="4665051"/>
            <a:ext cx="2315057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syringae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BL57G</a:t>
            </a: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7DFA6A4-0003-8129-8AD5-E2E5D12179AA}"/>
              </a:ext>
            </a:extLst>
          </p:cNvPr>
          <p:cNvSpPr txBox="1"/>
          <p:nvPr/>
        </p:nvSpPr>
        <p:spPr>
          <a:xfrm>
            <a:off x="3666608" y="5516066"/>
            <a:ext cx="2971776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ramorum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PHST BL 55G</a:t>
            </a: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FFE657DC-CE45-1870-B0EA-774F8E4A4392}"/>
              </a:ext>
            </a:extLst>
          </p:cNvPr>
          <p:cNvSpPr txBox="1"/>
          <p:nvPr/>
        </p:nvSpPr>
        <p:spPr>
          <a:xfrm>
            <a:off x="3666608" y="2963022"/>
            <a:ext cx="2678938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erythroseptica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6180</a:t>
            </a: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31D086EE-C73F-CFF4-D4E5-881D4D3BA591}"/>
              </a:ext>
            </a:extLst>
          </p:cNvPr>
          <p:cNvSpPr txBox="1"/>
          <p:nvPr/>
        </p:nvSpPr>
        <p:spPr>
          <a:xfrm>
            <a:off x="3666608" y="6367081"/>
            <a:ext cx="2393604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hibernalis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BL41G</a:t>
            </a: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2EA1BACF-3338-1B8E-E827-5BABBA5F2CC9}"/>
              </a:ext>
            </a:extLst>
          </p:cNvPr>
          <p:cNvSpPr txBox="1"/>
          <p:nvPr/>
        </p:nvSpPr>
        <p:spPr>
          <a:xfrm>
            <a:off x="3666608" y="5941573"/>
            <a:ext cx="2626040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 i="1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Phytophthora lateralis </a:t>
            </a:r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CBS 168.42</a:t>
            </a: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6439C80B-4343-EB09-1F4F-638F202C64FD}"/>
              </a:ext>
            </a:extLst>
          </p:cNvPr>
          <p:cNvSpPr txBox="1"/>
          <p:nvPr/>
        </p:nvSpPr>
        <p:spPr>
          <a:xfrm>
            <a:off x="2529863" y="5627206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234BBD0E-45D5-6A16-6093-0F018CEE83B7}"/>
              </a:ext>
            </a:extLst>
          </p:cNvPr>
          <p:cNvSpPr txBox="1"/>
          <p:nvPr/>
        </p:nvSpPr>
        <p:spPr>
          <a:xfrm>
            <a:off x="1790664" y="5962422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700EB6B7-3BEA-99C7-A75A-96C6E0C9B7E5}"/>
              </a:ext>
            </a:extLst>
          </p:cNvPr>
          <p:cNvSpPr txBox="1"/>
          <p:nvPr/>
        </p:nvSpPr>
        <p:spPr>
          <a:xfrm>
            <a:off x="348989" y="4912212"/>
            <a:ext cx="530700" cy="325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517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  <a:endParaRPr lang="ja-JP" altLang="en-US" sz="1517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799E0508-0C25-72A0-E06D-8AA859C14D6E}"/>
              </a:ext>
            </a:extLst>
          </p:cNvPr>
          <p:cNvSpPr txBox="1"/>
          <p:nvPr/>
        </p:nvSpPr>
        <p:spPr>
          <a:xfrm>
            <a:off x="2532698" y="4381712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1517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  <a:endParaRPr lang="ja-JP" altLang="en-US" sz="1517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07F7F08A-520F-42F4-19CF-3D3A6972184E}"/>
              </a:ext>
            </a:extLst>
          </p:cNvPr>
          <p:cNvSpPr txBox="1"/>
          <p:nvPr/>
        </p:nvSpPr>
        <p:spPr>
          <a:xfrm>
            <a:off x="1077675" y="549386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6A31127D-2F17-B5DE-E6E1-89DA8A94B93D}"/>
              </a:ext>
            </a:extLst>
          </p:cNvPr>
          <p:cNvSpPr txBox="1"/>
          <p:nvPr/>
        </p:nvSpPr>
        <p:spPr>
          <a:xfrm>
            <a:off x="2535470" y="353208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F707549F-7E5C-FB94-163C-0AAB0511F307}"/>
              </a:ext>
            </a:extLst>
          </p:cNvPr>
          <p:cNvSpPr txBox="1"/>
          <p:nvPr/>
        </p:nvSpPr>
        <p:spPr>
          <a:xfrm>
            <a:off x="1804618" y="3210461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DA3E00D5-E80A-C452-A5F3-6AD483AC7124}"/>
              </a:ext>
            </a:extLst>
          </p:cNvPr>
          <p:cNvSpPr txBox="1"/>
          <p:nvPr/>
        </p:nvSpPr>
        <p:spPr>
          <a:xfrm>
            <a:off x="1064679" y="2811268"/>
            <a:ext cx="449162" cy="325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517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100</a:t>
            </a: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CF06E377-8CEA-EB5E-6875-F4B02461B02F}"/>
              </a:ext>
            </a:extLst>
          </p:cNvPr>
          <p:cNvSpPr txBox="1"/>
          <p:nvPr/>
        </p:nvSpPr>
        <p:spPr>
          <a:xfrm>
            <a:off x="7019848" y="3112130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a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BD5D59AA-1AF8-C597-EFB0-561D612AB996}"/>
              </a:ext>
            </a:extLst>
          </p:cNvPr>
          <p:cNvSpPr txBox="1"/>
          <p:nvPr/>
        </p:nvSpPr>
        <p:spPr>
          <a:xfrm>
            <a:off x="6989353" y="4167905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b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D5A015C9-4F1A-72A1-DDCD-8FFA10FE4CAD}"/>
              </a:ext>
            </a:extLst>
          </p:cNvPr>
          <p:cNvSpPr txBox="1"/>
          <p:nvPr/>
        </p:nvSpPr>
        <p:spPr>
          <a:xfrm>
            <a:off x="6989353" y="4642536"/>
            <a:ext cx="42191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d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A278C442-59EB-0CC4-2C37-C799E4BF432D}"/>
              </a:ext>
            </a:extLst>
          </p:cNvPr>
          <p:cNvSpPr txBox="1"/>
          <p:nvPr/>
        </p:nvSpPr>
        <p:spPr>
          <a:xfrm>
            <a:off x="6989353" y="5732238"/>
            <a:ext cx="409086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8c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AFDF7FA3-06FE-A547-BBE0-9AB18272114A}"/>
              </a:ext>
            </a:extLst>
          </p:cNvPr>
          <p:cNvSpPr txBox="1"/>
          <p:nvPr/>
        </p:nvSpPr>
        <p:spPr>
          <a:xfrm>
            <a:off x="6989353" y="6733846"/>
            <a:ext cx="409086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sz="2022" dirty="0">
                <a:ln/>
                <a:solidFill>
                  <a:srgbClr val="000000"/>
                </a:solidFill>
                <a:latin typeface="Arial Narrow" panose="020B0604020202020204" pitchFamily="34" charset="0"/>
                <a:cs typeface="Arial Narrow" panose="020B0604020202020204" pitchFamily="34" charset="0"/>
                <a:sym typeface="Arial"/>
                <a:rtl val="0"/>
              </a:rPr>
              <a:t>7c</a:t>
            </a:r>
            <a:endParaRPr lang="ja-JP" altLang="en-US" sz="2022">
              <a:ln/>
              <a:solidFill>
                <a:srgbClr val="000000"/>
              </a:solidFill>
              <a:latin typeface="Arial Narrow" panose="020B0604020202020204" pitchFamily="34" charset="0"/>
              <a:cs typeface="Arial Narrow" panose="020B0604020202020204" pitchFamily="34" charset="0"/>
              <a:sym typeface="Arial"/>
              <a:rtl val="0"/>
            </a:endParaRPr>
          </a:p>
        </p:txBody>
      </p:sp>
    </p:spTree>
    <p:extLst>
      <p:ext uri="{BB962C8B-B14F-4D97-AF65-F5344CB8AC3E}">
        <p14:creationId xmlns:p14="http://schemas.microsoft.com/office/powerpoint/2010/main" val="1531099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</TotalTime>
  <Words>370</Words>
  <Application>Microsoft Macintosh PowerPoint</Application>
  <PresentationFormat>A4 Paper (210x297 mm)</PresentationFormat>
  <Paragraphs>25</Paragraphs>
  <Slides>2</Slides>
  <Notes>0</Notes>
  <HiddenSlides>1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Arial</vt:lpstr>
      <vt:lpstr>Arial Narrow</vt:lpstr>
      <vt:lpstr>Calibri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viewer</dc:creator>
  <cp:lastModifiedBy>Hai Nguyen</cp:lastModifiedBy>
  <cp:revision>13</cp:revision>
  <dcterms:created xsi:type="dcterms:W3CDTF">2024-09-26T19:49:03Z</dcterms:created>
  <dcterms:modified xsi:type="dcterms:W3CDTF">2025-05-12T14:55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4-11T18:17:13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85c741bd-dfa9-475d-8cb2-7849fd20b971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Office テーマ:8</vt:lpwstr>
  </property>
  <property fmtid="{D5CDD505-2E9C-101B-9397-08002B2CF9AE}" pid="11" name="ClassificationContentMarkingHeaderText">
    <vt:lpwstr>Unclassified / Non classifié</vt:lpwstr>
  </property>
</Properties>
</file>